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2" d="100"/>
          <a:sy n="32" d="100"/>
        </p:scale>
        <p:origin x="4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8BAB7A5-D0EE-081A-ABBC-3D603C2BCF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B6A794CF-82FF-E31F-2159-1D499FD546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482377A-5B46-8C95-2DF1-453871B56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BFEC6E8-A3FB-2B03-FFB9-96B21FD635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8B1325E4-3EF0-C81E-9DEC-3DA2440BE2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92776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721722A-9495-D56D-2D01-87F85FDBA2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2517FB45-138C-8776-0976-0B85B371BD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4E27F0F-6494-40CC-96BF-ACE668E6D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6F07FD9F-C41D-EA47-8387-FFAF04137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59B53872-16D5-BEF6-AD83-34393907D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79279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2ABBA9DD-6768-5BCF-ADE6-494800BED5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3F8B717C-B75A-29E0-71F7-D3E12440AA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C773FDB-97FA-19FC-D0C8-EA16D50DD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C85E2596-3248-66E7-7028-8CA1DDE335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A15221D-16D9-8309-44A8-7EE3CEF1F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65263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83D7AD9-5E4A-4463-5ECB-C442E2CD53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000B2966-79F2-C126-CC49-63CF1302A4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772F2170-BCA4-5409-54B7-DAB1005E43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7F1E199A-348E-71B1-BD59-AF71BF049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3C452B6-7CE1-38A8-0A81-965D83E4E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4730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8742087-9610-9C64-B10B-DC24F21BF0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49B312F9-8C75-5A0B-27C1-B1476A3C82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A22180E-BFF1-062D-80B9-F838DEE1D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5F93D961-5E69-7AAF-79D9-212775EB3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375C658-3C76-38FB-FAAD-55D104EB64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48665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B41D1B1-E8AA-4743-AEB5-AB2428260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93AD1B56-5280-8BAB-82A7-78AE07A122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49E3CA9C-CF6A-B578-565F-0C6573E42C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71FE069A-7AC4-9F68-B832-77A13B7C3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4CF4AB4C-C87B-0528-F2F7-D41700E77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0089DC37-D75C-E490-D6FE-6929D1C25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91622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6F89032-4BD2-8D55-EE6B-51C9A7576F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1BD422A5-50B1-D1F5-6604-2732C7D6A8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46528F3E-F10A-37E1-B321-E230F37C1B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EF261034-5A45-140A-5EC6-4AC992B784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8A4FB3B8-5FDE-F92C-43B4-616155A3D0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344CE3B0-5C03-21A2-B127-E4D70A7A9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AE21438C-FD8A-EE56-35E0-9543DBD85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437C9A5A-3A14-95D3-6898-F3DCCD0B5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72702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2E94822-6144-3880-1092-B98B0285DD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B3F6F6FB-A802-F7AE-8A87-0E8C1FCB8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2D21B736-AD06-EBB8-FFD0-DA26DF247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AD8B9E80-07A6-AC4C-A8F0-A06E524BD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6154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F37D7873-26CB-6BF5-E5D0-7F84C95C7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A86212BD-0327-6173-8CE6-B9B600115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71339A5A-1FFF-B0DA-04DB-B51076CAA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62799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22D622F-0198-244D-0333-B929C0BDF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6F4A5CB1-310E-80D2-9C0E-958DAB7167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8CA8B206-1476-84C4-DDA6-F05C8CAF04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1E6B57E8-F9E8-4214-2BFA-5911814D5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94EA5F45-881C-7383-B0CA-5612DA84C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733B37E-EBB5-6693-1036-5B991C2EE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22280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C3F9F2A-7C5A-7B29-2CEB-BA78E960E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69C93BD7-F504-E701-59E3-689617B0CE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78D05667-89BC-79AC-A05F-647528D0B9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08172B16-8C1F-3ED5-125B-FE9D17390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78BD4EC0-4676-EAD5-FCEC-475BB78CC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44DF09E4-939F-25D0-EADE-7BD1A865F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95860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D6063767-E63E-E8BF-85C0-8832BCAA3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2AC937E4-01D4-70C7-6C1C-D16AD7765E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02DD390E-8532-05B1-F11E-101B2FB9CE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F6927D6-3750-11C3-C92A-0F317A9769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5884E285-788F-9D87-44A2-336E02D36E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  <p:sp>
        <p:nvSpPr>
          <p:cNvPr id="8" name="textruta 7">
            <a:extLst>
              <a:ext uri="{FF2B5EF4-FFF2-40B4-BE49-F238E27FC236}">
                <a16:creationId xmlns:a16="http://schemas.microsoft.com/office/drawing/2014/main" id="{04FC597B-C66C-5B6C-78C8-EEED8FFE5C46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11363325" y="63500"/>
            <a:ext cx="787400" cy="12192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sv-SE" sz="80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egränsad delning</a:t>
            </a:r>
          </a:p>
        </p:txBody>
      </p:sp>
    </p:spTree>
    <p:extLst>
      <p:ext uri="{BB962C8B-B14F-4D97-AF65-F5344CB8AC3E}">
        <p14:creationId xmlns:p14="http://schemas.microsoft.com/office/powerpoint/2010/main" val="3253284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ruta 2">
            <a:extLst>
              <a:ext uri="{FF2B5EF4-FFF2-40B4-BE49-F238E27FC236}">
                <a16:creationId xmlns:a16="http://schemas.microsoft.com/office/drawing/2014/main" id="{516C66D9-65F7-FBFB-58E1-02AF83284A31}"/>
              </a:ext>
            </a:extLst>
          </p:cNvPr>
          <p:cNvSpPr txBox="1"/>
          <p:nvPr/>
        </p:nvSpPr>
        <p:spPr>
          <a:xfrm>
            <a:off x="827314" y="315936"/>
            <a:ext cx="10842172" cy="4576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Appendix figure 1.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hange in relative inequities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in total and financial-related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unmet oral care needs for 48 intersectional strata in three study periods.</a:t>
            </a:r>
            <a:endParaRPr lang="sv-SE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9" name="textruta 8">
            <a:extLst>
              <a:ext uri="{FF2B5EF4-FFF2-40B4-BE49-F238E27FC236}">
                <a16:creationId xmlns:a16="http://schemas.microsoft.com/office/drawing/2014/main" id="{4CD8B3FF-DD35-4C25-7289-F068884D7681}"/>
              </a:ext>
            </a:extLst>
          </p:cNvPr>
          <p:cNvSpPr txBox="1"/>
          <p:nvPr/>
        </p:nvSpPr>
        <p:spPr>
          <a:xfrm>
            <a:off x="990600" y="5416307"/>
            <a:ext cx="9971314" cy="11257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: Total unmet oral care needs. b: Financial-related unmet oral care needs. </a:t>
            </a:r>
            <a:endParaRPr lang="sv-SE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oints represent prevalence ratios of total and financial-related unmet oral care needs, with native men aged &gt;65 years with high education and high income as the reference stratum.</a:t>
            </a:r>
            <a:endParaRPr lang="sv-SE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8" name="Bildobjekt 7" descr="En bild som visar text, skärmbild, diagram, Graf&#10;&#10;Automatiskt genererad beskrivning">
            <a:extLst>
              <a:ext uri="{FF2B5EF4-FFF2-40B4-BE49-F238E27FC236}">
                <a16:creationId xmlns:a16="http://schemas.microsoft.com/office/drawing/2014/main" id="{89261A62-AD8A-066C-4B08-6571B20E98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4862" y="1230283"/>
            <a:ext cx="7822276" cy="4397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5771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f13b610e-d3b5-490f-b165-988100e8232a}" enabled="1" method="Standard" siteId="{5a4ba6f9-f531-4f32-9467-398f19e69de4}" contentBits="1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72</Words>
  <Application>Microsoft Office PowerPoint</Application>
  <PresentationFormat>Bredbild</PresentationFormat>
  <Paragraphs>3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Cynthia Anticona Huaynate</dc:creator>
  <cp:lastModifiedBy>Cynthia Anticona Huaynate</cp:lastModifiedBy>
  <cp:revision>14</cp:revision>
  <dcterms:created xsi:type="dcterms:W3CDTF">2024-04-30T06:12:33Z</dcterms:created>
  <dcterms:modified xsi:type="dcterms:W3CDTF">2024-11-01T10:13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lassificationContentMarkingHeaderLocations">
    <vt:lpwstr>Office-tema:8</vt:lpwstr>
  </property>
  <property fmtid="{D5CDD505-2E9C-101B-9397-08002B2CF9AE}" pid="3" name="ClassificationContentMarkingHeaderText">
    <vt:lpwstr>Begränsad delning</vt:lpwstr>
  </property>
</Properties>
</file>